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324A32-F974-408E-9876-268462C6E1B0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AD08D3-DD27-454A-9514-86791068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2414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: Schema</a:t>
            </a:r>
          </a:p>
        </p:txBody>
      </p:sp>
    </p:spTree>
    <p:extLst>
      <p:ext uri="{BB962C8B-B14F-4D97-AF65-F5344CB8AC3E}">
        <p14:creationId xmlns:p14="http://schemas.microsoft.com/office/powerpoint/2010/main" val="8248910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ure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5312BC7-9F1F-8041-A3DA-E58296FA6B73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5543742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3F832-87F8-FC9C-185A-009183FCA4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3422F7-B720-1DC3-89C7-4558F90519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C5C55-1207-24AC-74FC-ADEDF884C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F07476-F164-5608-E382-9EDA0ADD8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8025A-9AF8-A93C-0443-C14186DA5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107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C744D0-13D8-57A8-EECE-4B6DB6900F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450473-E537-FD9E-1D0E-A8DA2AA8A1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EAD01-CBC1-6DA3-552A-4BB0AB801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C80B9-C2AE-51CB-C91E-A78EADE13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62AE11-7D78-1648-544C-F60438546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384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8618C3-D5B4-1EC3-AD19-33C6621185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D12A68-CC52-EFFB-0674-8153C63FE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03410-EED9-0A28-8B85-F9D0E314B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4E643-3503-8545-ACCD-6EB601749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7B0A6-4B63-6385-4A56-BA5C1F3B0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3293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122208139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852024-7E09-2B38-D891-882B0262D3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7CD91C-EA96-8C83-A216-4742EEA39A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78E5BA-85B8-6336-8B73-165F5A6A7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392035-B8F3-6292-B135-0A42B59FE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E369C-2E4F-8E20-85E2-A38005321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175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08843-4009-3B34-7793-71C56115B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EE1425-CF24-4204-82D7-8E815F9A30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67E964-3927-0678-BA74-ED2562B9C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793B1E-066E-5556-A235-ED54BDEDE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D71CAC-A221-834E-7A77-CCE7331BC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996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0012E2-8180-04EF-E0DE-569FC0D13F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887C8A-692D-2D69-6872-0945FE394A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ECA66C-107F-90F2-F9B4-D1CED1D426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398C2B-79AA-7FD4-CD0C-012F517B2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6B1EF2-C35A-B827-0DAD-EE3281A27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13F599-5A8B-EE10-9FB0-F332FEA2D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438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E2BD12-61A5-0998-04E3-FAB15DC558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10534B-2FC1-F550-523D-1109C774F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41938A-B44B-0EFC-4D11-B566924500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FEBE89-558D-7CA0-5672-70B74473A6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8E7B9B-1B6F-70DA-8E4B-55C0B1F40B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CA33F0-2476-54FB-24F5-0F3AF140C1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274CAF-0BDC-0C7E-B235-290573C44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C62490-724D-8DB5-5DB2-BAF9D884B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625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93D5D-9E89-5E6A-E147-3C5CCFCEF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108474-C926-F563-DF38-8F574697B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C2AD51-9FC4-22BC-CC17-7A17DE2E5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023F9A0-888F-6DCF-440D-4A21CC0A5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47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381E28-C23F-2587-7294-D9088CF38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B359BB-77C1-1BF2-28AA-1C394A0CE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2A0957-7723-01C4-A82B-686D5AB1B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3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6B6A53-3A4F-0F24-6980-FC4758804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C2F19C-92B0-8874-DC25-EAFC1E43C0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C6BC40-7F6B-9C9B-2EB0-C124145FA4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A1497-C0C1-7FCC-EB40-0049E5BB0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3981B4-6FBB-3778-6640-3AAC206D2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EA1BFB-D0CB-530E-7F9E-2E52AD72A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268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5D328-9F83-5BE4-0003-CBAE8B657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B59B84-E701-5126-106D-0051C0BD71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A4B1C3-08A3-6DF7-9DCC-15D90719BE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E456DD-F634-941E-22FB-D5CBA7239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18101-BF18-A297-A690-E4676232D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C860AD-5D65-4ED2-A269-35956505C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87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6DA2A4-60C0-8BE5-55CF-0E86018A0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49DEFB-7B17-37DF-8E20-9360A1B002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35399-EAE2-3848-1B19-3B2B5F01B3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98BF2E-F96F-424D-B95B-C02E96D3DA95}" type="datetimeFigureOut">
              <a:rPr lang="en-US" smtClean="0"/>
              <a:t>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1E77C0-5BA8-1BFF-575A-677466C401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F06DAF-01F2-E05B-B6A7-0215911079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F00C5B-B742-40FF-8EE4-01D8609070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901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rocess 5">
            <a:extLst>
              <a:ext uri="{FF2B5EF4-FFF2-40B4-BE49-F238E27FC236}">
                <a16:creationId xmlns:a16="http://schemas.microsoft.com/office/drawing/2014/main" id="{72BDA688-CD30-8C4A-B77D-4A60EF81250E}"/>
              </a:ext>
            </a:extLst>
          </p:cNvPr>
          <p:cNvSpPr/>
          <p:nvPr/>
        </p:nvSpPr>
        <p:spPr>
          <a:xfrm rot="10800000" flipV="1">
            <a:off x="166876" y="631561"/>
            <a:ext cx="3215657" cy="4232196"/>
          </a:xfrm>
          <a:prstGeom prst="flowChartProcess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vanced Non-Squamou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D after platinum-based chemo (Prior IO and any mutation allowed in dose escalation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133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3+3 dose escalation to MTD in Arm A and Arm B. 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133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tarting dose level:  trametinib 1.5 mg daily (D1-1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7" name="Process 6">
            <a:extLst>
              <a:ext uri="{FF2B5EF4-FFF2-40B4-BE49-F238E27FC236}">
                <a16:creationId xmlns:a16="http://schemas.microsoft.com/office/drawing/2014/main" id="{69554632-C755-0640-B70F-436AAA65BCE4}"/>
              </a:ext>
            </a:extLst>
          </p:cNvPr>
          <p:cNvSpPr/>
          <p:nvPr/>
        </p:nvSpPr>
        <p:spPr>
          <a:xfrm rot="10800000" flipV="1">
            <a:off x="4383850" y="1136775"/>
            <a:ext cx="2822223" cy="1889235"/>
          </a:xfrm>
          <a:prstGeom prst="flowChartProcess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rm A: Lead in Trametinib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N=12)</a:t>
            </a:r>
          </a:p>
        </p:txBody>
      </p:sp>
      <p:sp>
        <p:nvSpPr>
          <p:cNvPr id="8" name="Process 7">
            <a:extLst>
              <a:ext uri="{FF2B5EF4-FFF2-40B4-BE49-F238E27FC236}">
                <a16:creationId xmlns:a16="http://schemas.microsoft.com/office/drawing/2014/main" id="{AA8634E5-D12A-0E4D-9BC6-875B80166449}"/>
              </a:ext>
            </a:extLst>
          </p:cNvPr>
          <p:cNvSpPr/>
          <p:nvPr/>
        </p:nvSpPr>
        <p:spPr>
          <a:xfrm rot="10800000" flipV="1">
            <a:off x="4383850" y="3281344"/>
            <a:ext cx="2822223" cy="1512939"/>
          </a:xfrm>
          <a:prstGeom prst="flowChartProcess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rm B: Lead in Pembrolizumab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N=12)</a:t>
            </a:r>
          </a:p>
        </p:txBody>
      </p:sp>
      <p:sp>
        <p:nvSpPr>
          <p:cNvPr id="9" name="Process 8">
            <a:extLst>
              <a:ext uri="{FF2B5EF4-FFF2-40B4-BE49-F238E27FC236}">
                <a16:creationId xmlns:a16="http://schemas.microsoft.com/office/drawing/2014/main" id="{B903DFFC-39E1-3C43-8C3A-8B2506731421}"/>
              </a:ext>
            </a:extLst>
          </p:cNvPr>
          <p:cNvSpPr/>
          <p:nvPr/>
        </p:nvSpPr>
        <p:spPr>
          <a:xfrm rot="10800000" flipV="1">
            <a:off x="8809470" y="751309"/>
            <a:ext cx="3277655" cy="2305496"/>
          </a:xfrm>
          <a:prstGeom prst="flowChartProcess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d pembrolizumab (week 3). Intercalated trametinib and pembrolizumab after C1 *  Disease Assessment Every 9 Weeks</a:t>
            </a:r>
          </a:p>
        </p:txBody>
      </p:sp>
      <p:sp>
        <p:nvSpPr>
          <p:cNvPr id="10" name="Process 9">
            <a:extLst>
              <a:ext uri="{FF2B5EF4-FFF2-40B4-BE49-F238E27FC236}">
                <a16:creationId xmlns:a16="http://schemas.microsoft.com/office/drawing/2014/main" id="{72876639-C467-D749-8809-27443E7A1BC4}"/>
              </a:ext>
            </a:extLst>
          </p:cNvPr>
          <p:cNvSpPr/>
          <p:nvPr/>
        </p:nvSpPr>
        <p:spPr>
          <a:xfrm rot="10800000" flipV="1">
            <a:off x="8838303" y="3129177"/>
            <a:ext cx="3186823" cy="2305484"/>
          </a:xfrm>
          <a:prstGeom prst="flowChartProcess">
            <a:avLst/>
          </a:prstGeom>
          <a:solidFill>
            <a:srgbClr val="C0504D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d Trametinib (week 3). Intercalated trametinib and pembrolizumab after C1 *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13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sease Assessment Every 9 Weeks</a:t>
            </a:r>
          </a:p>
        </p:txBody>
      </p:sp>
      <p:sp>
        <p:nvSpPr>
          <p:cNvPr id="11" name="TextBox 13">
            <a:extLst>
              <a:ext uri="{FF2B5EF4-FFF2-40B4-BE49-F238E27FC236}">
                <a16:creationId xmlns:a16="http://schemas.microsoft.com/office/drawing/2014/main" id="{756B37C6-A7CE-9D4C-B48F-304BE4A8A371}"/>
              </a:ext>
            </a:extLst>
          </p:cNvPr>
          <p:cNvSpPr txBox="1"/>
          <p:nvPr/>
        </p:nvSpPr>
        <p:spPr>
          <a:xfrm>
            <a:off x="83437" y="5664966"/>
            <a:ext cx="12025126" cy="954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67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ose escalation in Arm A and Arm B followed by dose expan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67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ametinib starting 10 days on and 11 days off. Starting dose level 1.5 mg daily (D1 D10). Paired biopsy baseline , on treatment and at progression (optional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E79FB75-0BE7-0D45-933A-A3BEC5F4BB88}"/>
              </a:ext>
            </a:extLst>
          </p:cNvPr>
          <p:cNvCxnSpPr>
            <a:cxnSpLocks/>
            <a:stCxn id="6" idx="1"/>
            <a:endCxn id="7" idx="3"/>
          </p:cNvCxnSpPr>
          <p:nvPr/>
        </p:nvCxnSpPr>
        <p:spPr>
          <a:xfrm flipV="1">
            <a:off x="3382532" y="2081392"/>
            <a:ext cx="1001317" cy="666267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EF896EC-D49D-9E4A-A4A3-C1EA73948C4A}"/>
              </a:ext>
            </a:extLst>
          </p:cNvPr>
          <p:cNvCxnSpPr>
            <a:cxnSpLocks/>
            <a:stCxn id="6" idx="1"/>
          </p:cNvCxnSpPr>
          <p:nvPr/>
        </p:nvCxnSpPr>
        <p:spPr>
          <a:xfrm>
            <a:off x="3382533" y="2747659"/>
            <a:ext cx="1001316" cy="1138541"/>
          </a:xfrm>
          <a:prstGeom prst="straightConnector1">
            <a:avLst/>
          </a:prstGeom>
          <a:ln w="34925"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663EF7B-A88B-2441-9188-3B09E2F45DF9}"/>
              </a:ext>
            </a:extLst>
          </p:cNvPr>
          <p:cNvCxnSpPr>
            <a:cxnSpLocks/>
          </p:cNvCxnSpPr>
          <p:nvPr/>
        </p:nvCxnSpPr>
        <p:spPr>
          <a:xfrm>
            <a:off x="7206070" y="2081392"/>
            <a:ext cx="1603400" cy="0"/>
          </a:xfrm>
          <a:prstGeom prst="straightConnector1">
            <a:avLst/>
          </a:prstGeom>
          <a:ln w="34925"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1E501EE-7D05-C141-B7C2-0F9C19241084}"/>
              </a:ext>
            </a:extLst>
          </p:cNvPr>
          <p:cNvCxnSpPr>
            <a:cxnSpLocks/>
            <a:stCxn id="8" idx="1"/>
          </p:cNvCxnSpPr>
          <p:nvPr/>
        </p:nvCxnSpPr>
        <p:spPr>
          <a:xfrm flipV="1">
            <a:off x="7206073" y="4037813"/>
            <a:ext cx="1603397" cy="1"/>
          </a:xfrm>
          <a:prstGeom prst="straightConnector1">
            <a:avLst/>
          </a:prstGeom>
          <a:ln w="34925"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C18C136-D045-65C0-92CA-764427E3ADF0}"/>
              </a:ext>
            </a:extLst>
          </p:cNvPr>
          <p:cNvSpPr txBox="1"/>
          <p:nvPr/>
        </p:nvSpPr>
        <p:spPr>
          <a:xfrm>
            <a:off x="83437" y="526483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1: Clinical Trial Schema</a:t>
            </a:r>
          </a:p>
        </p:txBody>
      </p:sp>
    </p:spTree>
    <p:extLst>
      <p:ext uri="{BB962C8B-B14F-4D97-AF65-F5344CB8AC3E}">
        <p14:creationId xmlns:p14="http://schemas.microsoft.com/office/powerpoint/2010/main" val="156783719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909DA13E-A25F-9247-9586-C6F607BA89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0108"/>
          <a:stretch/>
        </p:blipFill>
        <p:spPr>
          <a:xfrm>
            <a:off x="245466" y="1600200"/>
            <a:ext cx="2743200" cy="3200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DD3622C6-B9BC-6E4C-B564-7DA45C227A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2367" y="1600200"/>
            <a:ext cx="2743200" cy="3200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F82F6D9A-BDB2-0047-8F79-9B91862D675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7692"/>
          <a:stretch/>
        </p:blipFill>
        <p:spPr>
          <a:xfrm>
            <a:off x="3327922" y="1600200"/>
            <a:ext cx="2743200" cy="3200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38E7ACE5-4ECB-8643-B375-8A9A516F5AE9}"/>
              </a:ext>
            </a:extLst>
          </p:cNvPr>
          <p:cNvSpPr txBox="1"/>
          <p:nvPr/>
        </p:nvSpPr>
        <p:spPr>
          <a:xfrm>
            <a:off x="9431934" y="2765603"/>
            <a:ext cx="2514600" cy="2416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 Light" panose="020F0302020204030204"/>
                <a:ea typeface="+mn-ea"/>
                <a:cs typeface="+mn-cs"/>
              </a:rPr>
              <a:t>Quantitative Immunofluorescence of all tumor samples analyzed. The level of TILs in baseline samples was comparable across trial arms and dose regimens. (Arm A: Lead in Trametinib; Arm B: Lead in Pembrolizumab)</a:t>
            </a:r>
          </a:p>
        </p:txBody>
      </p:sp>
      <p:sp>
        <p:nvSpPr>
          <p:cNvPr id="2" name="CuadroTexto 9">
            <a:extLst>
              <a:ext uri="{FF2B5EF4-FFF2-40B4-BE49-F238E27FC236}">
                <a16:creationId xmlns:a16="http://schemas.microsoft.com/office/drawing/2014/main" id="{C1CBB78F-7AC1-B07D-61DC-27C733A60E4B}"/>
              </a:ext>
            </a:extLst>
          </p:cNvPr>
          <p:cNvSpPr txBox="1"/>
          <p:nvPr/>
        </p:nvSpPr>
        <p:spPr>
          <a:xfrm>
            <a:off x="9393141" y="2440904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2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 Light" panose="020F03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268818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99</Words>
  <Application>Microsoft Office PowerPoint</Application>
  <PresentationFormat>Widescreen</PresentationFormat>
  <Paragraphs>2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iley Creamer</dc:creator>
  <cp:lastModifiedBy>Bailey Creamer</cp:lastModifiedBy>
  <cp:revision>1</cp:revision>
  <dcterms:created xsi:type="dcterms:W3CDTF">2025-01-24T22:23:13Z</dcterms:created>
  <dcterms:modified xsi:type="dcterms:W3CDTF">2025-01-24T22:31:29Z</dcterms:modified>
</cp:coreProperties>
</file>